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712932512"/>
              </p:ext>
            </p:extLst>
          </p:nvPr>
        </p:nvGraphicFramePr>
        <p:xfrm>
          <a:off x="1083367" y="341740"/>
          <a:ext cx="9978885" cy="6446686"/>
        </p:xfrm>
        <a:graphic>
          <a:graphicData uri="http://schemas.openxmlformats.org/drawingml/2006/table">
            <a:tbl>
              <a:tblPr/>
              <a:tblGrid>
                <a:gridCol w="1678053">
                  <a:extLst>
                    <a:ext uri="{9D8B030D-6E8A-4147-A177-3AD203B41FA5}">
                      <a16:colId xmlns:a16="http://schemas.microsoft.com/office/drawing/2014/main" xmlns="" val="3264428470"/>
                    </a:ext>
                  </a:extLst>
                </a:gridCol>
                <a:gridCol w="742502">
                  <a:extLst>
                    <a:ext uri="{9D8B030D-6E8A-4147-A177-3AD203B41FA5}">
                      <a16:colId xmlns:a16="http://schemas.microsoft.com/office/drawing/2014/main" xmlns="" val="2893568198"/>
                    </a:ext>
                  </a:extLst>
                </a:gridCol>
                <a:gridCol w="1291954">
                  <a:extLst>
                    <a:ext uri="{9D8B030D-6E8A-4147-A177-3AD203B41FA5}">
                      <a16:colId xmlns:a16="http://schemas.microsoft.com/office/drawing/2014/main" xmlns="" val="2847428852"/>
                    </a:ext>
                  </a:extLst>
                </a:gridCol>
                <a:gridCol w="742502">
                  <a:extLst>
                    <a:ext uri="{9D8B030D-6E8A-4147-A177-3AD203B41FA5}">
                      <a16:colId xmlns:a16="http://schemas.microsoft.com/office/drawing/2014/main" xmlns="" val="2503886743"/>
                    </a:ext>
                  </a:extLst>
                </a:gridCol>
                <a:gridCol w="742502">
                  <a:extLst>
                    <a:ext uri="{9D8B030D-6E8A-4147-A177-3AD203B41FA5}">
                      <a16:colId xmlns:a16="http://schemas.microsoft.com/office/drawing/2014/main" xmlns="" val="2032837019"/>
                    </a:ext>
                  </a:extLst>
                </a:gridCol>
                <a:gridCol w="742502">
                  <a:extLst>
                    <a:ext uri="{9D8B030D-6E8A-4147-A177-3AD203B41FA5}">
                      <a16:colId xmlns:a16="http://schemas.microsoft.com/office/drawing/2014/main" xmlns="" val="1018808120"/>
                    </a:ext>
                  </a:extLst>
                </a:gridCol>
                <a:gridCol w="4038870">
                  <a:extLst>
                    <a:ext uri="{9D8B030D-6E8A-4147-A177-3AD203B41FA5}">
                      <a16:colId xmlns:a16="http://schemas.microsoft.com/office/drawing/2014/main" xmlns="" val="2255946665"/>
                    </a:ext>
                  </a:extLst>
                </a:gridCol>
              </a:tblGrid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ccession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000" dirty="0" smtClean="0"/>
                        <a:t>WT</a:t>
                      </a:r>
                      <a:endParaRPr lang="zh-CN" altLang="en-US" sz="1000" dirty="0"/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c1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g2 ratio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value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DR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escription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29735320"/>
                  </a:ext>
                </a:extLst>
              </a:tr>
              <a:tr h="2279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12g1760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869.1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855.7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.36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39835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ibulose bisphosphate carboxylase small chain, chloroplast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28511537"/>
                  </a:ext>
                </a:extLst>
              </a:tr>
              <a:tr h="23618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3860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738.3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461.3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82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849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lyceraldehyde-3-phosphate dehydroge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36505432"/>
                  </a:ext>
                </a:extLst>
              </a:tr>
              <a:tr h="205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0730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5.2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99.5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58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564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ibulose-phosphate 3-epimerase, chloroplast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462440"/>
                  </a:ext>
                </a:extLst>
              </a:tr>
              <a:tr h="205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10g21268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4903.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7123.9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.1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792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ibulose bisphosphate carboxylase large chain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78412779"/>
                  </a:ext>
                </a:extLst>
              </a:tr>
              <a:tr h="1844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0583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130.4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632.8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85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7353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ribulose bisphosphate carboxylase small chain, chloroplast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88835502"/>
                  </a:ext>
                </a:extLst>
              </a:tr>
              <a:tr h="205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0160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51.4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15.2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84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284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rythronate-4-phosphate dehydrogenase domain containing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otei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041325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0372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155.6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2972.7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51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138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lyceraldehyde-3-phosphate dehydroge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8693922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4702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39.2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072.5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1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821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hosphoribulokinase/Uridine kinase family protein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227672154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4899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0.0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41.6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2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275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4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uncharacterized kinase mug58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352512370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5722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64.5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114.3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9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23174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ydroxyacid oxidase 1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55553785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11g0702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399.1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0543.7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9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273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ructose-bisphospate aldolase isozym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42213444"/>
                  </a:ext>
                </a:extLst>
              </a:tr>
              <a:tr h="156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1668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58.9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62.8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607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ructose-1,6-bisphosphat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48000190"/>
                  </a:ext>
                </a:extLst>
              </a:tr>
              <a:tr h="205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5284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740.4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803.2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5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4046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erin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ydroxymethyltransferase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, mitochondrial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05347635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8g0270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27.3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90.1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1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316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ructose-bisphospate aldolase isozym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23083896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5g41640.3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7089.1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862.1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.1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538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hosphoglycerate kinase protein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80593514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5250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000.7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590.5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92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379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NADP-dependent malic enzym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30295159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6g3684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7.1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84.2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9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294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cysteine synth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95812519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6g4064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005.5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608.8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8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4049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fructose-bisphospate aldolase isozym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10331570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6009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969.4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1512.1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8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228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methylenetetrahydrofolate reduct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74008679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3319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38.8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60.9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8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165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P-binding enzym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31261233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5486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659.9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691.5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6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12705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noyl-CoA hydratase/isomerase family protein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76519430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5141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336.2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9947.6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6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5132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lycine dehydroge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74616029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5g3357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504.8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151.8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6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24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yruvate, phosphat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dikinase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, chloroplast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51022035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6g0427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1900.8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0751.9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4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8.41E-05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ransketolase, chloroplast precursor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23745204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5323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463.8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182.2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71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1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aminomethyltransfer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02500466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8g4481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912.0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6591.5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8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.93E-05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actate/malate dehydroge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55513949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5628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06.9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517.6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3094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actate/malate dehydroge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69722982"/>
                  </a:ext>
                </a:extLst>
              </a:tr>
              <a:tr h="205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2995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85.9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472.4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5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425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lucose-6-phosphate 1-dehydrogenase, chloroplast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57030968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5393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199.4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241.2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4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426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exoki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59277893"/>
                  </a:ext>
                </a:extLst>
              </a:tr>
              <a:tr h="2052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2g0115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319.7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521.8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38372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erythronate-4-phosphate dehydrogenase domain containing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otei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13596948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3g15050.2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403.8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285.7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6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3057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hosphoenolpyruvate carboxykin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49896140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9g3645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0551.5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6680.4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8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1224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riosephosphate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 isomerase, chloroplast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93819672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1g7017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5572.4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24448.1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5654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transaldolase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65361480"/>
                  </a:ext>
                </a:extLst>
              </a:tr>
              <a:tr h="1701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04g45970.2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71.7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516.6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6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866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glutamate dehydrogenase protein, putative, expressed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1508932"/>
                  </a:ext>
                </a:extLst>
              </a:tr>
              <a:tr h="1563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LOC_Os11g26860.1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9814.27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5291.33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1.56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36388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0.000 </a:t>
                      </a: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serine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hydroxymethyltransferase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, mitochondrial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precurs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767" marR="767" marT="76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86348184"/>
                  </a:ext>
                </a:extLst>
              </a:tr>
            </a:tbl>
          </a:graphicData>
        </a:graphic>
      </p:graphicFrame>
      <p:sp>
        <p:nvSpPr>
          <p:cNvPr id="2" name="矩形 1"/>
          <p:cNvSpPr/>
          <p:nvPr/>
        </p:nvSpPr>
        <p:spPr>
          <a:xfrm>
            <a:off x="980660" y="33978"/>
            <a:ext cx="1088666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sz="1400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1.5-fold alterations of proteins involved in carbon metabolism in comparison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fc17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iTRAQ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data to that of the WT</a:t>
            </a:r>
          </a:p>
        </p:txBody>
      </p:sp>
    </p:spTree>
    <p:extLst>
      <p:ext uri="{BB962C8B-B14F-4D97-AF65-F5344CB8AC3E}">
        <p14:creationId xmlns:p14="http://schemas.microsoft.com/office/powerpoint/2010/main" xmlns="" val="99037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8</TotalTime>
  <Words>458</Words>
  <Application>Microsoft Office PowerPoint</Application>
  <PresentationFormat>Custom</PresentationFormat>
  <Paragraphs>25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9</cp:revision>
  <cp:lastPrinted>2018-10-21T01:09:07Z</cp:lastPrinted>
  <dcterms:created xsi:type="dcterms:W3CDTF">2018-01-28T13:46:17Z</dcterms:created>
  <dcterms:modified xsi:type="dcterms:W3CDTF">2018-10-27T13:10:57Z</dcterms:modified>
</cp:coreProperties>
</file>